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231911-A6B9-4EC6-83FE-E9C78AB9C320}" v="1" dt="2024-06-21T15:37:53.6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690" y="34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2C231911-A6B9-4EC6-83FE-E9C78AB9C320}"/>
    <pc:docChg chg="custSel delSld modSld">
      <pc:chgData name="Mireille Vankemmelbeke" userId="e2496c92-8ae2-4817-81db-1e2fdf7923b3" providerId="ADAL" clId="{2C231911-A6B9-4EC6-83FE-E9C78AB9C320}" dt="2024-06-21T15:38:08.702" v="4" actId="47"/>
      <pc:docMkLst>
        <pc:docMk/>
      </pc:docMkLst>
      <pc:sldChg chg="delSp modSp mod">
        <pc:chgData name="Mireille Vankemmelbeke" userId="e2496c92-8ae2-4817-81db-1e2fdf7923b3" providerId="ADAL" clId="{2C231911-A6B9-4EC6-83FE-E9C78AB9C320}" dt="2024-06-21T15:38:05.002" v="2" actId="1076"/>
        <pc:sldMkLst>
          <pc:docMk/>
          <pc:sldMk cId="3935331238" sldId="268"/>
        </pc:sldMkLst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7" creationId="{79992CF2-F656-6E86-8F97-EAE850C1D6A1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8" creationId="{52FC7288-0277-B97D-DFD0-DDE8537FA61F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9" creationId="{329F8FB0-E780-D480-8A95-4E9518BEA6E8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11" creationId="{C837B6D7-0600-4F78-4369-7FBEBF40A86E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12" creationId="{C8E8BB72-0835-9E31-583F-D761EAD1BFAD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13" creationId="{F4565631-9F4F-C4D0-1CFB-0C52011139CC}"/>
          </ac:spMkLst>
        </pc:spChg>
        <pc:spChg chg="mod">
          <ac:chgData name="Mireille Vankemmelbeke" userId="e2496c92-8ae2-4817-81db-1e2fdf7923b3" providerId="ADAL" clId="{2C231911-A6B9-4EC6-83FE-E9C78AB9C320}" dt="2024-06-21T15:38:05.002" v="2" actId="1076"/>
          <ac:spMkLst>
            <pc:docMk/>
            <pc:sldMk cId="3935331238" sldId="268"/>
            <ac:spMk id="15" creationId="{6FC8C258-8525-A2DF-0C57-7C5EB072650E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16" creationId="{3A6C0FD7-6959-1587-2E5D-AAEB3F8465DA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18" creationId="{F4E7CC6C-854B-6244-16A0-7FDF0F15E499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20" creationId="{647588B9-6635-78F5-91C7-12C820028590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21" creationId="{8BA43F7C-912C-8ECD-6D13-02611A596775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23" creationId="{1323D973-24A6-69E1-63BB-AAE450CCC9E6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27" creationId="{0E1505E9-4973-7FF0-A4E6-FB325AF9754F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28" creationId="{5A31E918-6C9F-EF42-0695-E0BDCB0A7C3D}"/>
          </ac:spMkLst>
        </pc:spChg>
        <pc:spChg chg="del">
          <ac:chgData name="Mireille Vankemmelbeke" userId="e2496c92-8ae2-4817-81db-1e2fdf7923b3" providerId="ADAL" clId="{2C231911-A6B9-4EC6-83FE-E9C78AB9C320}" dt="2024-06-21T15:37:53.606" v="0" actId="478"/>
          <ac:spMkLst>
            <pc:docMk/>
            <pc:sldMk cId="3935331238" sldId="268"/>
            <ac:spMk id="38" creationId="{C7DDF822-B914-4A88-9466-5C023EC4895A}"/>
          </ac:spMkLst>
        </pc:spChg>
        <pc:grpChg chg="del">
          <ac:chgData name="Mireille Vankemmelbeke" userId="e2496c92-8ae2-4817-81db-1e2fdf7923b3" providerId="ADAL" clId="{2C231911-A6B9-4EC6-83FE-E9C78AB9C320}" dt="2024-06-21T15:37:53.606" v="0" actId="478"/>
          <ac:grpSpMkLst>
            <pc:docMk/>
            <pc:sldMk cId="3935331238" sldId="268"/>
            <ac:grpSpMk id="4" creationId="{CA438E9F-47E1-3BF7-4DBF-311027FCC2F7}"/>
          </ac:grpSpMkLst>
        </pc:grpChg>
        <pc:grpChg chg="del">
          <ac:chgData name="Mireille Vankemmelbeke" userId="e2496c92-8ae2-4817-81db-1e2fdf7923b3" providerId="ADAL" clId="{2C231911-A6B9-4EC6-83FE-E9C78AB9C320}" dt="2024-06-21T15:37:53.606" v="0" actId="478"/>
          <ac:grpSpMkLst>
            <pc:docMk/>
            <pc:sldMk cId="3935331238" sldId="268"/>
            <ac:grpSpMk id="26" creationId="{FCF721D8-5A65-D3C4-1D36-67958D25B49C}"/>
          </ac:grpSpMkLst>
        </pc:grpChg>
        <pc:grpChg chg="del">
          <ac:chgData name="Mireille Vankemmelbeke" userId="e2496c92-8ae2-4817-81db-1e2fdf7923b3" providerId="ADAL" clId="{2C231911-A6B9-4EC6-83FE-E9C78AB9C320}" dt="2024-06-21T15:37:53.606" v="0" actId="478"/>
          <ac:grpSpMkLst>
            <pc:docMk/>
            <pc:sldMk cId="3935331238" sldId="268"/>
            <ac:grpSpMk id="35" creationId="{5D514B5C-2C50-A53F-809C-1892AF271196}"/>
          </ac:grpSpMkLst>
        </pc:grpChg>
        <pc:picChg chg="del">
          <ac:chgData name="Mireille Vankemmelbeke" userId="e2496c92-8ae2-4817-81db-1e2fdf7923b3" providerId="ADAL" clId="{2C231911-A6B9-4EC6-83FE-E9C78AB9C320}" dt="2024-06-21T15:37:53.606" v="0" actId="478"/>
          <ac:picMkLst>
            <pc:docMk/>
            <pc:sldMk cId="3935331238" sldId="268"/>
            <ac:picMk id="10" creationId="{86DA2D0F-ED30-6908-6CA2-9BFDE4C80CA0}"/>
          </ac:picMkLst>
        </pc:picChg>
        <pc:picChg chg="del">
          <ac:chgData name="Mireille Vankemmelbeke" userId="e2496c92-8ae2-4817-81db-1e2fdf7923b3" providerId="ADAL" clId="{2C231911-A6B9-4EC6-83FE-E9C78AB9C320}" dt="2024-06-21T15:37:55.838" v="1" actId="478"/>
          <ac:picMkLst>
            <pc:docMk/>
            <pc:sldMk cId="3935331238" sldId="268"/>
            <ac:picMk id="29" creationId="{9EF0A7CC-D44C-B781-66A4-D496E53F1767}"/>
          </ac:picMkLst>
        </pc:picChg>
        <pc:picChg chg="del">
          <ac:chgData name="Mireille Vankemmelbeke" userId="e2496c92-8ae2-4817-81db-1e2fdf7923b3" providerId="ADAL" clId="{2C231911-A6B9-4EC6-83FE-E9C78AB9C320}" dt="2024-06-21T15:37:53.606" v="0" actId="478"/>
          <ac:picMkLst>
            <pc:docMk/>
            <pc:sldMk cId="3935331238" sldId="268"/>
            <ac:picMk id="30" creationId="{42508664-B0C7-213A-5AAF-AFE57EC6C254}"/>
          </ac:picMkLst>
        </pc:picChg>
        <pc:picChg chg="del">
          <ac:chgData name="Mireille Vankemmelbeke" userId="e2496c92-8ae2-4817-81db-1e2fdf7923b3" providerId="ADAL" clId="{2C231911-A6B9-4EC6-83FE-E9C78AB9C320}" dt="2024-06-21T15:37:53.606" v="0" actId="478"/>
          <ac:picMkLst>
            <pc:docMk/>
            <pc:sldMk cId="3935331238" sldId="268"/>
            <ac:picMk id="32" creationId="{D71BB802-F8FA-B9F5-62FE-6DDA85DC0CC0}"/>
          </ac:picMkLst>
        </pc:picChg>
        <pc:picChg chg="mod">
          <ac:chgData name="Mireille Vankemmelbeke" userId="e2496c92-8ae2-4817-81db-1e2fdf7923b3" providerId="ADAL" clId="{2C231911-A6B9-4EC6-83FE-E9C78AB9C320}" dt="2024-06-21T15:38:05.002" v="2" actId="1076"/>
          <ac:picMkLst>
            <pc:docMk/>
            <pc:sldMk cId="3935331238" sldId="268"/>
            <ac:picMk id="34" creationId="{D395F453-6B32-21CF-E7D4-65CAAE1691F0}"/>
          </ac:picMkLst>
        </pc:picChg>
        <pc:picChg chg="del">
          <ac:chgData name="Mireille Vankemmelbeke" userId="e2496c92-8ae2-4817-81db-1e2fdf7923b3" providerId="ADAL" clId="{2C231911-A6B9-4EC6-83FE-E9C78AB9C320}" dt="2024-06-21T15:37:53.606" v="0" actId="478"/>
          <ac:picMkLst>
            <pc:docMk/>
            <pc:sldMk cId="3935331238" sldId="268"/>
            <ac:picMk id="37" creationId="{241969AE-1E1E-FCFD-3B20-ADCF726A6A95}"/>
          </ac:picMkLst>
        </pc:picChg>
        <pc:picChg chg="del">
          <ac:chgData name="Mireille Vankemmelbeke" userId="e2496c92-8ae2-4817-81db-1e2fdf7923b3" providerId="ADAL" clId="{2C231911-A6B9-4EC6-83FE-E9C78AB9C320}" dt="2024-06-21T15:37:53.606" v="0" actId="478"/>
          <ac:picMkLst>
            <pc:docMk/>
            <pc:sldMk cId="3935331238" sldId="268"/>
            <ac:picMk id="39" creationId="{8AA96BB3-6D0F-13D6-28DB-C113A52F9100}"/>
          </ac:picMkLst>
        </pc:picChg>
      </pc:sldChg>
      <pc:sldChg chg="del">
        <pc:chgData name="Mireille Vankemmelbeke" userId="e2496c92-8ae2-4817-81db-1e2fdf7923b3" providerId="ADAL" clId="{2C231911-A6B9-4EC6-83FE-E9C78AB9C320}" dt="2024-06-21T15:38:07.676" v="3" actId="47"/>
        <pc:sldMkLst>
          <pc:docMk/>
          <pc:sldMk cId="868960993" sldId="269"/>
        </pc:sldMkLst>
      </pc:sldChg>
      <pc:sldChg chg="del">
        <pc:chgData name="Mireille Vankemmelbeke" userId="e2496c92-8ae2-4817-81db-1e2fdf7923b3" providerId="ADAL" clId="{2C231911-A6B9-4EC6-83FE-E9C78AB9C320}" dt="2024-06-21T15:38:08.702" v="4" actId="47"/>
        <pc:sldMkLst>
          <pc:docMk/>
          <pc:sldMk cId="226879392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">
            <a:extLst>
              <a:ext uri="{FF2B5EF4-FFF2-40B4-BE49-F238E27FC236}">
                <a16:creationId xmlns:a16="http://schemas.microsoft.com/office/drawing/2014/main" id="{6FC8C258-8525-A2DF-0C57-7C5EB072650E}"/>
              </a:ext>
            </a:extLst>
          </p:cNvPr>
          <p:cNvSpPr txBox="1"/>
          <p:nvPr/>
        </p:nvSpPr>
        <p:spPr>
          <a:xfrm>
            <a:off x="160722" y="955142"/>
            <a:ext cx="66972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4. </a:t>
            </a:r>
            <a:r>
              <a:rPr lang="en-GB" sz="9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ximum cytotoxicity exerted by 10nM SC134-TCB in a 48-hour coculture of DMS79 with PBMC or Pan T cells as effectors (E:T, 5:1). Target cell killing measured by LDH and flow-based Live/dead staining. 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32A62937-3779-0616-05B7-500E83122552}"/>
              </a:ext>
            </a:extLst>
          </p:cNvPr>
          <p:cNvSpPr txBox="1">
            <a:spLocks/>
          </p:cNvSpPr>
          <p:nvPr/>
        </p:nvSpPr>
        <p:spPr>
          <a:xfrm>
            <a:off x="95251" y="359591"/>
            <a:ext cx="5604510" cy="4227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s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D395F453-6B32-21CF-E7D4-65CAAE1691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t="8338" r="1118" b="37807"/>
          <a:stretch/>
        </p:blipFill>
        <p:spPr>
          <a:xfrm>
            <a:off x="324994" y="1348091"/>
            <a:ext cx="2366391" cy="13053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331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38:10Z</dcterms:modified>
</cp:coreProperties>
</file>